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415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8C24C9F-424F-4730-8859-E5437CA577B4}" type="datetimeFigureOut">
              <a:rPr lang="en-US" smtClean="0"/>
              <a:t>3/11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15D3873-6A0E-4FFB-8063-8E4510012C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4556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ayt Görüntüsü Yer Tutucusu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 Yer Tutucusu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tr-TR" dirty="0"/>
          </a:p>
        </p:txBody>
      </p:sp>
      <p:sp>
        <p:nvSpPr>
          <p:cNvPr id="4" name="Slayt Numarası Yer Tutucusu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rtl="0"/>
            <a:fld id="{4B725628-3A68-42F4-BA86-981817953149}" type="slidenum">
              <a:rPr lang="tr-TR" noProof="0" smtClean="0"/>
              <a:t>1</a:t>
            </a:fld>
            <a:endParaRPr lang="tr-TR" noProof="0" dirty="0"/>
          </a:p>
        </p:txBody>
      </p:sp>
    </p:spTree>
    <p:extLst>
      <p:ext uri="{BB962C8B-B14F-4D97-AF65-F5344CB8AC3E}">
        <p14:creationId xmlns:p14="http://schemas.microsoft.com/office/powerpoint/2010/main" val="6127762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0D3330-2DF7-4A9E-AFD4-949E4185C24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2201203-3E45-4892-A148-734DABDF2C7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BD7482-7B07-4629-8C75-8C07F7A212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9477F-1CA9-4266-B87B-28D2958BCC13}" type="datetimeFigureOut">
              <a:rPr lang="en-US" smtClean="0"/>
              <a:t>3/1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A65C16-007B-4AE9-B7E9-450E3301EA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A3103D-1DC4-4550-A54E-0CA165D534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9A2116-EA04-4769-B22C-7C92ECF615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89217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07A254-031A-4BF0-BD5F-810DA54A38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ADF929F-2BAA-40E3-9FFC-C0BAFAB5260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AB859B-B937-4523-A3E6-DD2B37A9E4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9477F-1CA9-4266-B87B-28D2958BCC13}" type="datetimeFigureOut">
              <a:rPr lang="en-US" smtClean="0"/>
              <a:t>3/1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83147F-4F24-4BF2-94E3-C6D6F672FB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0E7A62-8DF2-49D3-809F-BF6D2184B5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9A2116-EA04-4769-B22C-7C92ECF615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79878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993EF3E-0BB0-48A9-B50B-DAA71383F40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9A4375C-399B-45F7-A85C-DF66FF9BDFE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17F93D-3053-4E8C-839B-192CD0DF33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9477F-1CA9-4266-B87B-28D2958BCC13}" type="datetimeFigureOut">
              <a:rPr lang="en-US" smtClean="0"/>
              <a:t>3/1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0D3CFB-662A-4F5D-ADEA-EDF75DAB4A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18874E-EA1F-47B9-8526-39F77AEA27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9A2116-EA04-4769-B22C-7C92ECF615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8248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BF246C-F940-4D24-9436-8115DAC9C9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6BB0373-3FE6-4E3E-A6C2-9800FD89B26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26969D-D45F-4A92-B849-6B20F31574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9477F-1CA9-4266-B87B-28D2958BCC13}" type="datetimeFigureOut">
              <a:rPr lang="en-US" smtClean="0"/>
              <a:t>3/1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A69142-FE80-4EAF-B54C-8C9914FC6B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330C48-29E1-499D-86C9-E1BAC9A09A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9A2116-EA04-4769-B22C-7C92ECF615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52959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2EA2C2-9292-4514-A5A1-009DEEC6A2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A2E4697-092B-4CAE-A477-E28F8718C6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9428BA-6C5C-477D-9FC1-ACDABBB807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9477F-1CA9-4266-B87B-28D2958BCC13}" type="datetimeFigureOut">
              <a:rPr lang="en-US" smtClean="0"/>
              <a:t>3/1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9D6159-F2EA-4AF0-AF87-81D5E0624E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240289-A5BD-4B00-8A8B-C0BE686C53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9A2116-EA04-4769-B22C-7C92ECF615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78948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135748-9A42-42E8-8EBC-7A4D002581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860AB42-C7D8-4831-BB3C-A98C88A9F2B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537168E-1FFE-45D9-8DD6-72906D24817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332AF06-49AC-4816-99BC-7BB4B75E97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9477F-1CA9-4266-B87B-28D2958BCC13}" type="datetimeFigureOut">
              <a:rPr lang="en-US" smtClean="0"/>
              <a:t>3/1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226AC0C-1C58-41EE-809D-765004238F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EA4BD1A-E4C2-4022-A124-1A310F219B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9A2116-EA04-4769-B22C-7C92ECF615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91385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E6982F-4D61-426A-8F8C-BF9E441F99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2A81255-6374-4302-B358-24D5FC83F2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07F7241-DBC0-4D36-B42A-20208448B78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649C197-7766-4626-9DE7-7D8AC38A3FE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F1CA681-3BAB-4B3B-904C-3FAD8E10634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315CE20-8D6D-4466-9286-542CB16593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9477F-1CA9-4266-B87B-28D2958BCC13}" type="datetimeFigureOut">
              <a:rPr lang="en-US" smtClean="0"/>
              <a:t>3/11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28FCE76-64AD-4AD0-B026-A4D985E766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DCF958B-1CF1-499D-85FF-19F1086825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9A2116-EA04-4769-B22C-7C92ECF615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50034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93121E-5398-4AA6-BC2C-276A4F3A8F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C09C336-920B-4100-B799-08A6AF5AB5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9477F-1CA9-4266-B87B-28D2958BCC13}" type="datetimeFigureOut">
              <a:rPr lang="en-US" smtClean="0"/>
              <a:t>3/11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3A25DC0-2FBC-4324-A8D4-ABF0785A12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A3BD1EC-DF35-4EED-88AD-D0826E6514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9A2116-EA04-4769-B22C-7C92ECF615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7379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439DFD8-CA42-4304-A106-312F01F162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9477F-1CA9-4266-B87B-28D2958BCC13}" type="datetimeFigureOut">
              <a:rPr lang="en-US" smtClean="0"/>
              <a:t>3/11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94B2B01-4CD3-4D07-8C7F-03EF8B2E63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64AEAAF-5F4D-420D-9169-BA40E0C528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9A2116-EA04-4769-B22C-7C92ECF615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03687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E9D9AC-3FA7-45D0-B2BB-72D0616253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76BAEA7-821C-4335-A728-48F91916342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ACF5268-6447-4A88-B624-970DFF77063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EB54600-AA3D-4525-981C-121D84EA9A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9477F-1CA9-4266-B87B-28D2958BCC13}" type="datetimeFigureOut">
              <a:rPr lang="en-US" smtClean="0"/>
              <a:t>3/1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EF37D61-D3EF-4F7B-80FE-A0D06E3DD3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CEDB582-3DC6-4EDC-BDC0-C955B2F94B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9A2116-EA04-4769-B22C-7C92ECF615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64762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E45BA1-60AD-4F7D-9DB0-391E1C79CF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844B76F-6E8F-472A-BAB7-F63E66849FE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B0EA336-44AC-40CC-859F-58F661E8EF9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43578F6-C770-40AD-8C98-418C9958D4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9477F-1CA9-4266-B87B-28D2958BCC13}" type="datetimeFigureOut">
              <a:rPr lang="en-US" smtClean="0"/>
              <a:t>3/1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FF5BB8-07B7-47C6-8D7F-CD469EAD14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4EE1CAF-94D5-439B-8B3E-B87B2C8190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9A2116-EA04-4769-B22C-7C92ECF615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57437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4BEF0A0-701E-42B8-BE2C-5D418338C2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C77C84-642B-45CF-9789-9E9537A8ED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ADF763-A31E-4FD6-9506-5A429B32251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79477F-1CA9-4266-B87B-28D2958BCC13}" type="datetimeFigureOut">
              <a:rPr lang="en-US" smtClean="0"/>
              <a:t>3/1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A7FC18-BFA2-4F36-B1DC-87A87C8EB8B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581F77-2992-4DF1-93E9-C2F512EC116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9A2116-EA04-4769-B22C-7C92ECF615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89801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png"/><Relationship Id="rId3" Type="http://schemas.microsoft.com/office/2007/relationships/media" Target="../media/media2.mp4"/><Relationship Id="rId7" Type="http://schemas.openxmlformats.org/officeDocument/2006/relationships/image" Target="../media/image1.pn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notesSlide" Target="../notesSlides/notesSlide1.xml"/><Relationship Id="rId5" Type="http://schemas.openxmlformats.org/officeDocument/2006/relationships/slideLayout" Target="../slideLayouts/slideLayout2.xml"/><Relationship Id="rId4" Type="http://schemas.openxmlformats.org/officeDocument/2006/relationships/video" Target="../media/media2.mp4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44"/>
          <p:cNvSpPr>
            <a:spLocks noChangeArrowheads="1"/>
          </p:cNvSpPr>
          <p:nvPr/>
        </p:nvSpPr>
        <p:spPr bwMode="auto">
          <a:xfrm>
            <a:off x="6677526" y="201169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tr-TR"/>
          </a:p>
        </p:txBody>
      </p:sp>
      <p:pic>
        <p:nvPicPr>
          <p:cNvPr id="7" name="2npA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225278" y="1380937"/>
            <a:ext cx="5959499" cy="3206695"/>
          </a:xfrm>
          <a:prstGeom prst="rect">
            <a:avLst/>
          </a:prstGeom>
          <a:ln w="1270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15" name="2np-2disA-2">
            <a:hlinkClick r:id="" action="ppaction://media"/>
            <a:extLst>
              <a:ext uri="{FF2B5EF4-FFF2-40B4-BE49-F238E27FC236}">
                <a16:creationId xmlns:a16="http://schemas.microsoft.com/office/drawing/2014/main" id="{38054796-0679-445A-B912-F51528B3037F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8"/>
          <a:stretch>
            <a:fillRect/>
          </a:stretch>
        </p:blipFill>
        <p:spPr>
          <a:xfrm>
            <a:off x="6308411" y="886962"/>
            <a:ext cx="5584973" cy="4194646"/>
          </a:xfrm>
          <a:prstGeom prst="rect">
            <a:avLst/>
          </a:prstGeom>
          <a:ln w="1270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2835DD32-2CAF-4A52-A9D6-434162CBA6EE}"/>
              </a:ext>
            </a:extLst>
          </p:cNvPr>
          <p:cNvSpPr/>
          <p:nvPr/>
        </p:nvSpPr>
        <p:spPr>
          <a:xfrm>
            <a:off x="447049" y="5470858"/>
            <a:ext cx="1129790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ludge particles in the a) absence and b) presence of two PIBSI dispersant intercalated between two sludge particles. 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1B01CF3-0243-4679-BF92-FBC4FF1A5A70}"/>
              </a:ext>
            </a:extLst>
          </p:cNvPr>
          <p:cNvSpPr txBox="1"/>
          <p:nvPr/>
        </p:nvSpPr>
        <p:spPr>
          <a:xfrm>
            <a:off x="353491" y="1508399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3D9FF43-7A7B-4356-BAD0-4CA645E5E8DC}"/>
              </a:ext>
            </a:extLst>
          </p:cNvPr>
          <p:cNvSpPr txBox="1"/>
          <p:nvPr/>
        </p:nvSpPr>
        <p:spPr>
          <a:xfrm>
            <a:off x="6390306" y="1127464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32431349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1000"/>
                                        <p:tgtEl>
                                          <p:spTgt spid="7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8" dur="10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9" dur="10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0" fill="hold">
                      <p:stCondLst>
                        <p:cond delay="indefinite"/>
                      </p:stCondLst>
                      <p:childTnLst>
                        <p:par>
                          <p:cTn id="11" fill="hold">
                            <p:stCondLst>
                              <p:cond delay="0"/>
                            </p:stCondLst>
                            <p:childTnLst>
                              <p:par>
                                <p:cTn id="12" presetID="42" presetClass="exit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13" dur="1000"/>
                                        <p:tgtEl>
                                          <p:spTgt spid="7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14" dur="1000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ppt_x"/>
                                          </p:val>
                                        </p:tav>
                                        <p:tav tm="100000">
                                          <p:val>
                                            <p:strVal val="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5" dur="1000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ppt_y"/>
                                          </p:val>
                                        </p:tav>
                                        <p:tav tm="100000">
                                          <p:val>
                                            <p:strVal val="ppt_y+.1"/>
                                          </p:val>
                                        </p:tav>
                                      </p:tavLst>
                                    </p:anim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999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  <p:cmd type="call" cmd="stop">
                                      <p:cBhvr>
                                        <p:cTn id="17" dur="1">
                                          <p:stCondLst>
                                            <p:cond delay="999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8" fill="hold">
                      <p:stCondLst>
                        <p:cond delay="indefinite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42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2" dur="1000"/>
                                        <p:tgtEl>
                                          <p:spTgt spid="15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23" dur="1000" fill="hold"/>
                                        <p:tgtEl>
                                          <p:spTgt spid="15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4" dur="1000" fill="hold"/>
                                        <p:tgtEl>
                                          <p:spTgt spid="15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5" fill="hold">
                      <p:stCondLst>
                        <p:cond delay="indefinite"/>
                      </p:stCondLst>
                      <p:childTnLst>
                        <p:par>
                          <p:cTn id="26" fill="hold">
                            <p:stCondLst>
                              <p:cond delay="0"/>
                            </p:stCondLst>
                            <p:childTnLst>
                              <p:par>
                                <p:cTn id="27" presetID="42" presetClass="exit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28" dur="1000"/>
                                        <p:tgtEl>
                                          <p:spTgt spid="15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29" dur="1000"/>
                                        <p:tgtEl>
                                          <p:spTgt spid="15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ppt_x"/>
                                          </p:val>
                                        </p:tav>
                                        <p:tav tm="100000">
                                          <p:val>
                                            <p:strVal val="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30" dur="1000"/>
                                        <p:tgtEl>
                                          <p:spTgt spid="15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ppt_y"/>
                                          </p:val>
                                        </p:tav>
                                        <p:tav tm="100000">
                                          <p:val>
                                            <p:strVal val="ppt_y+.1"/>
                                          </p:val>
                                        </p:tav>
                                      </p:tavLst>
                                    </p:anim>
                                    <p:set>
                                      <p:cBhvr>
                                        <p:cTn id="31" dur="1" fill="hold">
                                          <p:stCondLst>
                                            <p:cond delay="999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  <p:cmd type="call" cmd="stop">
                                      <p:cBhvr>
                                        <p:cTn id="32" dur="1">
                                          <p:stCondLst>
                                            <p:cond delay="999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33" fill="hold" display="0">
                  <p:stCondLst>
                    <p:cond delay="indefinite"/>
                  </p:stCondLst>
                </p:cTn>
                <p:tgtEl>
                  <p:spTgt spid="7"/>
                </p:tgtEl>
              </p:cMediaNode>
            </p:video>
            <p:video>
              <p:cMediaNode vol="80000">
                <p:cTn id="34" fill="hold" display="0">
                  <p:stCondLst>
                    <p:cond delay="indefinite"/>
                  </p:stCondLst>
                </p:cTn>
                <p:tgtEl>
                  <p:spTgt spid="15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24</Words>
  <Application>Microsoft Office PowerPoint</Application>
  <PresentationFormat>Widescreen</PresentationFormat>
  <Paragraphs>4</Paragraphs>
  <Slides>1</Slides>
  <Notes>1</Notes>
  <HiddenSlides>0</HiddenSlides>
  <MMClips>2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rolyildirim</dc:creator>
  <cp:lastModifiedBy>erolyildirim</cp:lastModifiedBy>
  <cp:revision>4</cp:revision>
  <dcterms:created xsi:type="dcterms:W3CDTF">2025-03-11T10:59:48Z</dcterms:created>
  <dcterms:modified xsi:type="dcterms:W3CDTF">2025-03-11T18:31:33Z</dcterms:modified>
</cp:coreProperties>
</file>